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84" y="540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0DA91D-F062-4ECE-8762-C1C1D01D6A58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006B28-8813-496B-AD38-5A1D474EDD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280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006B28-8813-496B-AD38-5A1D474EDD4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78474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10.jpeg"/><Relationship Id="rId7" Type="http://schemas.openxmlformats.org/officeDocument/2006/relationships/image" Target="../media/image14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Relationship Id="rId9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I:\lab data\Chemical stain\clinical plaque staining\Project_yaq-ftl_RAW_ch00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28" y="198884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I:\lab data\Chemical stain\clinical plaque staining\Project_yaq-fz_RAW_ch0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30" y="441069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3" descr="I:\lab data\Chemical stain\clinical plaque staining\Project_sgl-ftl-1_RAW_ch00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3485" y="198884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 descr="I:\lab data\Chemical stain\clinical plaque staining\Project_sgl-fz-1_RAW_ch0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3486" y="441069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5" descr="I:\lab data\Chemical stain\clinical plaque staining\Project_nmc-ftl-1_RAW_ch00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9642" y="198884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6" descr="I:\lab data\Chemical stain\clinical plaque staining\Project_nmc-fz_RAW_ch00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9642" y="441069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9" descr="I:\lab data\Chemical stain\clinical plaque staining\Project_myz-ftl_RAW_ch00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15798" y="198884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0" descr="I:\lab data\Chemical stain\clinical plaque staining\Project_myz-fz_RAW_ch00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15798" y="4410698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"/>
          <p:cNvSpPr txBox="1"/>
          <p:nvPr/>
        </p:nvSpPr>
        <p:spPr>
          <a:xfrm>
            <a:off x="1277174" y="1675092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1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4333331" y="1675092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2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7392957" y="1675092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3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10449114" y="1675092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4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62114" y="332656"/>
            <a:ext cx="35595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Up: IHC of </a:t>
            </a:r>
            <a:r>
              <a:rPr lang="en-US" altLang="zh-CN" dirty="0" err="1" smtClean="0"/>
              <a:t>FtL</a:t>
            </a:r>
            <a:endParaRPr lang="en-US" altLang="zh-CN" dirty="0" smtClean="0"/>
          </a:p>
          <a:p>
            <a:r>
              <a:rPr lang="en-US" altLang="zh-CN" dirty="0" smtClean="0"/>
              <a:t>Below: DAB enhanced Prussian blu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65685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6" descr="I:\lab data\Chemical stain\clinical plaque staining\Project_wp-fth_RAW_ch00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1997" y="162904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7" descr="I:\lab data\Chemical stain\clinical plaque staining\Project_wp-fz_RAW_ch00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0029" y="4077312"/>
            <a:ext cx="2880001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8" descr="I:\lab data\Chemical stain\clinical plaque staining\Project_txz-ftl_RAW_ch0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6192330" y="162904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0" descr="I:\lab data\Chemical stain\clinical plaque staining\Project_txz-fz-1_RAW_ch00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8395" y="4077312"/>
            <a:ext cx="2880001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2" descr="I:\lab data\Chemical stain\clinical plaque staining\Project_lmj-fz_RAW_ch0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6760" y="4074605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3" descr="I:\lab data\Chemical stain\clinical plaque staining\Project_lmj-ftl_RAW_ch00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92664" y="162904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6" descr="I:\lab data\Chemical stain\clinical plaque staining\Project_frz-ftl_RAW_ch00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664" y="1629040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7" descr="I:\lab data\Chemical stain\clinical plaque staining\Project_frz-fz_RAW_ch00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191664" y="4077312"/>
            <a:ext cx="28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文本框 9"/>
          <p:cNvSpPr txBox="1"/>
          <p:nvPr/>
        </p:nvSpPr>
        <p:spPr>
          <a:xfrm>
            <a:off x="62114" y="332656"/>
            <a:ext cx="35595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Up: IHC of </a:t>
            </a:r>
            <a:r>
              <a:rPr lang="en-US" altLang="zh-CN" dirty="0" err="1" smtClean="0"/>
              <a:t>FtL</a:t>
            </a:r>
            <a:endParaRPr lang="en-US" altLang="zh-CN" dirty="0" smtClean="0"/>
          </a:p>
          <a:p>
            <a:r>
              <a:rPr lang="en-US" altLang="zh-CN" dirty="0" smtClean="0"/>
              <a:t>Below: DAB enhanced Prussian blue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1271464" y="1331476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5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4327621" y="1331476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6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7387247" y="1331476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7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10443404" y="1331476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6145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31</Words>
  <Application>Microsoft Office PowerPoint</Application>
  <PresentationFormat>宽屏</PresentationFormat>
  <Paragraphs>13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宋体</vt:lpstr>
      <vt:lpstr>Arial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</dc:creator>
  <cp:lastModifiedBy>Dr.Xu</cp:lastModifiedBy>
  <cp:revision>7</cp:revision>
  <dcterms:created xsi:type="dcterms:W3CDTF">2021-03-14T01:37:02Z</dcterms:created>
  <dcterms:modified xsi:type="dcterms:W3CDTF">2022-06-07T14:28:28Z</dcterms:modified>
</cp:coreProperties>
</file>